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FC62725-24E5-4947-A53E-856E36730362}" v="2" dt="2026-03-06T13:18:04.6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5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mimuzzaman, MD - REE-ARS, NE" userId="c4c0c4bf-d3ff-4635-ac06-6d8ad717c455" providerId="ADAL" clId="{5E179223-0B2A-4242-839F-4DB5828EE8F3}"/>
    <pc:docChg chg="custSel addSld modSld">
      <pc:chgData name="Shamimuzzaman, MD - REE-ARS, NE" userId="c4c0c4bf-d3ff-4635-ac06-6d8ad717c455" providerId="ADAL" clId="{5E179223-0B2A-4242-839F-4DB5828EE8F3}" dt="2026-03-06T13:28:22.890" v="358" actId="20577"/>
      <pc:docMkLst>
        <pc:docMk/>
      </pc:docMkLst>
      <pc:sldChg chg="addSp delSp modSp new mod">
        <pc:chgData name="Shamimuzzaman, MD - REE-ARS, NE" userId="c4c0c4bf-d3ff-4635-ac06-6d8ad717c455" providerId="ADAL" clId="{5E179223-0B2A-4242-839F-4DB5828EE8F3}" dt="2026-03-06T13:28:22.890" v="358" actId="20577"/>
        <pc:sldMkLst>
          <pc:docMk/>
          <pc:sldMk cId="2938316584" sldId="256"/>
        </pc:sldMkLst>
        <pc:spChg chg="add mod">
          <ac:chgData name="Shamimuzzaman, MD - REE-ARS, NE" userId="c4c0c4bf-d3ff-4635-ac06-6d8ad717c455" providerId="ADAL" clId="{5E179223-0B2A-4242-839F-4DB5828EE8F3}" dt="2026-03-06T13:24:22.149" v="210" actId="208"/>
          <ac:spMkLst>
            <pc:docMk/>
            <pc:sldMk cId="2938316584" sldId="256"/>
            <ac:spMk id="2" creationId="{BD026A6F-2CAA-7E51-9D2F-1B00C344FDF6}"/>
          </ac:spMkLst>
        </pc:spChg>
        <pc:spChg chg="del">
          <ac:chgData name="Shamimuzzaman, MD - REE-ARS, NE" userId="c4c0c4bf-d3ff-4635-ac06-6d8ad717c455" providerId="ADAL" clId="{5E179223-0B2A-4242-839F-4DB5828EE8F3}" dt="2026-03-06T13:13:04.668" v="1" actId="478"/>
          <ac:spMkLst>
            <pc:docMk/>
            <pc:sldMk cId="2938316584" sldId="256"/>
            <ac:spMk id="2" creationId="{CC948C71-396D-EF21-F5E8-E6185DE4703B}"/>
          </ac:spMkLst>
        </pc:spChg>
        <pc:spChg chg="del">
          <ac:chgData name="Shamimuzzaman, MD - REE-ARS, NE" userId="c4c0c4bf-d3ff-4635-ac06-6d8ad717c455" providerId="ADAL" clId="{5E179223-0B2A-4242-839F-4DB5828EE8F3}" dt="2026-03-06T13:13:07.335" v="2" actId="478"/>
          <ac:spMkLst>
            <pc:docMk/>
            <pc:sldMk cId="2938316584" sldId="256"/>
            <ac:spMk id="3" creationId="{285E80BC-2EF5-D8DC-46B2-C8BFC4C4EE0A}"/>
          </ac:spMkLst>
        </pc:spChg>
        <pc:spChg chg="add mod">
          <ac:chgData name="Shamimuzzaman, MD - REE-ARS, NE" userId="c4c0c4bf-d3ff-4635-ac06-6d8ad717c455" providerId="ADAL" clId="{5E179223-0B2A-4242-839F-4DB5828EE8F3}" dt="2026-03-06T13:28:22.890" v="358" actId="20577"/>
          <ac:spMkLst>
            <pc:docMk/>
            <pc:sldMk cId="2938316584" sldId="256"/>
            <ac:spMk id="7" creationId="{7702DDEE-0840-D811-C706-433542C17C37}"/>
          </ac:spMkLst>
        </pc:spChg>
        <pc:picChg chg="add mod modCrop">
          <ac:chgData name="Shamimuzzaman, MD - REE-ARS, NE" userId="c4c0c4bf-d3ff-4635-ac06-6d8ad717c455" providerId="ADAL" clId="{5E179223-0B2A-4242-839F-4DB5828EE8F3}" dt="2026-03-06T13:17:09.282" v="27" actId="1076"/>
          <ac:picMkLst>
            <pc:docMk/>
            <pc:sldMk cId="2938316584" sldId="256"/>
            <ac:picMk id="4" creationId="{CFFDFC6C-274E-13EB-EC10-7C66B0110B32}"/>
          </ac:picMkLst>
        </pc:picChg>
        <pc:picChg chg="add del mod modCrop">
          <ac:chgData name="Shamimuzzaman, MD - REE-ARS, NE" userId="c4c0c4bf-d3ff-4635-ac06-6d8ad717c455" providerId="ADAL" clId="{5E179223-0B2A-4242-839F-4DB5828EE8F3}" dt="2026-03-06T13:16:17.380" v="23" actId="478"/>
          <ac:picMkLst>
            <pc:docMk/>
            <pc:sldMk cId="2938316584" sldId="256"/>
            <ac:picMk id="6" creationId="{DE4B8243-6CFF-A098-93FE-0946C646A1EC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6521E7-6D17-484D-ADB1-512222098B91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432A68-524A-42F4-A2AF-5136EBBE91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407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432A68-524A-42F4-A2AF-5136EBBE91B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4817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1C18D6-E3DA-0E7F-698F-7DFF11F37B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96FC19-2079-E0AE-8220-A334E0AACC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C924F-DC5C-DF6A-2AC6-6D47D3B2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789258-51A4-35F5-2EB9-E0F7CE55A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EB0D32-B325-D5A9-D51D-D84627829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03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68BD8B-C7F6-33C0-B750-70257C31DC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239A76-0CD3-5E40-1575-7C267AD9D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7CFC0A-34CF-FF47-22B0-FB5074058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C6D50-3060-4F7C-ADB3-78A3267D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ABDF9-A735-6DF6-DFFD-81FCF5740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251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EEB2C4-B927-FEB1-0236-50FA49F38C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680472-B1F2-62F1-4389-ABB3B387CE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32818-11D1-17C8-3799-EAA05364D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FBCD3C-D253-1B8C-9862-CAE311F8C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0187EB-FAC6-C6E8-C0EC-7EFE7EAC3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096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1BEB9-C70A-E348-851E-4131652118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0012B1-FBDF-7E8E-18D0-FB4F64D2BD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97EFC-5A7D-806F-8970-6BDE608DE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F5E6A1-F172-36DF-39C7-A47DE780D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60B12-450E-EC88-A169-5F602BB20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323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E6F7D-3DB7-68B1-686A-FE85E93931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4FCC65-EA82-1E5F-2173-1585ACEFF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9655E5-FD83-47C9-4B10-1D9E8C7DE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E4BAB2-2B40-54BC-0FA3-B3D12AF4F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3E2F66-6A00-0022-37F5-B0D2C2239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44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53BB6-EF72-FDC5-5EDF-D770CBC70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4DF79-4B90-AE16-597C-54AA65D769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0B3FBA-05F3-3040-344F-8FBBBBCD5E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4808E-F621-4AF3-9489-694E81CDE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D968F0-7F51-6DC6-B166-88E7AA0F9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5A5D55-2B62-3E7E-74ED-335C6B7F3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33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F0654-5B42-4169-5D68-2F57BA7C1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EBBAF1-E9FE-048C-93E4-FBA6CFF8B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21E2E5-A1B9-38DA-D02E-8D310AADDC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A66D9C-41C6-71C4-7C7F-7A93480E39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F9BD9C-DFF6-98A6-B664-33C75256B0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76724E-E57C-9DDB-486E-6D4B8F6A7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CF3DF9-1BF2-3A3C-E5D6-AE0AF71E9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B30E86-65A4-B843-8AB6-732EFE579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53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298FD-5125-6F02-7B9C-E26E5D89B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1BCBE1-F8EE-823A-8D89-3C528767F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9338A5-5050-3A7F-ADDD-32C47333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F409B1-8239-7A52-5BC3-9F574DDDD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576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D43464-13EC-1664-B185-9BF0190E3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C0FA71-62CC-7D38-5C4A-CC2FED439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72E186-BB85-8663-F6AC-87A5DFCB0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675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A9F11-6385-BCF6-584E-84D05208A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36CC79-AFD0-09F9-A022-DEB13B1398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B006EF-5CE5-9AA5-3C6E-5354294F63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16AEDF-D686-6A57-CFED-E4341813B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E9BB3F-8733-11C1-2942-0A5D92AC1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C4DB4-4735-90A5-C10C-83F70429D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15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1B6D5-06F8-1A1C-BD17-5DB84905C8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0A6707-A44A-4B0D-72CC-D6E71D1F8B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349AC5-61C1-6D18-DF19-AE8BFC6FB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9344C5-B6AF-80A4-C633-AD2AFA336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B7A655-445D-9C42-0EAF-B075C4167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FED097-6534-D095-7AD7-F2A10422B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59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1075CA-0699-115A-CB15-A2AF40314E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7E1A7A-0554-C21E-3417-07BBC9E790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563ECF-1A68-6429-3B67-862D891CC4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DFFED8-EE4D-4B17-8221-6A58D677A96E}" type="datetimeFigureOut">
              <a:rPr lang="en-US" smtClean="0"/>
              <a:t>3/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F987BB-F5B2-9548-D658-756BBE2D2A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7ED860-E3D2-3FE6-BA00-B319140D13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9A8434-81F4-41FE-B5E3-6A02A8747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56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text, application&#10;&#10;AI-generated content may be incorrect.">
            <a:extLst>
              <a:ext uri="{FF2B5EF4-FFF2-40B4-BE49-F238E27FC236}">
                <a16:creationId xmlns:a16="http://schemas.microsoft.com/office/drawing/2014/main" id="{CFFDFC6C-274E-13EB-EC10-7C66B0110B3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5" t="8476" r="30452" b="35809"/>
          <a:stretch>
            <a:fillRect/>
          </a:stretch>
        </p:blipFill>
        <p:spPr bwMode="auto">
          <a:xfrm>
            <a:off x="400525" y="316230"/>
            <a:ext cx="11606787" cy="5850890"/>
          </a:xfrm>
          <a:prstGeom prst="rect">
            <a:avLst/>
          </a:prstGeom>
          <a:ln w="9525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702DDEE-0840-D811-C706-433542C17C37}"/>
              </a:ext>
            </a:extLst>
          </p:cNvPr>
          <p:cNvSpPr txBox="1"/>
          <p:nvPr/>
        </p:nvSpPr>
        <p:spPr>
          <a:xfrm>
            <a:off x="280413" y="6310937"/>
            <a:ext cx="116067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op 3 enriched motifs identified by MEME suite in the promoter regions of the differentially expressed defense-related genes. The second enriched motif is ethylene response binding motif also known as GCC-box motif (highlighted in green box)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D026A6F-2CAA-7E51-9D2F-1B00C344FDF6}"/>
              </a:ext>
            </a:extLst>
          </p:cNvPr>
          <p:cNvSpPr/>
          <p:nvPr/>
        </p:nvSpPr>
        <p:spPr>
          <a:xfrm>
            <a:off x="541865" y="4174067"/>
            <a:ext cx="11345335" cy="999066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316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d5b36e7-01ee-4ebc-867e-e03cfa0d4697}" enabled="0" method="" siteId="{ed5b36e7-01ee-4ebc-867e-e03cfa0d4697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35</TotalTime>
  <Words>44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mimuzzaman, MD - REE-ARS, NE</dc:creator>
  <cp:lastModifiedBy>Kai Shu ling</cp:lastModifiedBy>
  <cp:revision>3</cp:revision>
  <dcterms:created xsi:type="dcterms:W3CDTF">2026-03-06T13:12:58Z</dcterms:created>
  <dcterms:modified xsi:type="dcterms:W3CDTF">2026-03-08T04:37:14Z</dcterms:modified>
</cp:coreProperties>
</file>